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DEBF2-4A3A-426C-9C93-8301845ABF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E5F9C-DD2A-4F82-A468-E19ED889B8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4A2AD-0F27-4012-BC80-3D4A6BA612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7B3EB-09F1-490C-9E07-B701C2235B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51AAB-8828-4417-B4F2-1F65D73492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7F08F-319C-4D9C-A627-B02AC1DED8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7765C-B30B-4EC2-B19C-0C756BCF3F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DED86-8AF8-4ED4-951B-41D29ECFF2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0B4F2-6E45-454B-B5BC-001E3359C4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3948E-5EF7-436F-9C6B-CF16C9CA0F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6DE0B-8B31-403E-97B7-A16883E498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57CC5-6441-4D49-9BA9-CA43FCAF52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0DFE4B-4B33-4B25-A0D5-82754BB2804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JEllis@JournalReview.org?subject=Mohs%20math%20-%20where%20the%20error%20hides" TargetMode="External"/><Relationship Id="rId2" Type="http://schemas.openxmlformats.org/officeDocument/2006/relationships/hyperlink" Target="http://www.biomedcentral.com/logon/logon.asp?msg=ce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creativecommons.org/licenses/by/2.0" TargetMode="External"/><Relationship Id="rId5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hyperlink" Target="http://www.biomedcentral.com/1471-5945/6/10" TargetMode="External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hyperlink" Target="http://www.biomedcentral.com/1471-5945/6/10" TargetMode="External"/><Relationship Id="rId1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Times New Roman"/>
              </a:rPr>
              <a:t>Mohs math – where the error hides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80773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Jeffrey I Ellis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(</a:t>
            </a:r>
            <a:r>
              <a:rPr b="0" lang="en-US" sz="1800" spc="-1" strike="noStrike" u="sng">
                <a:solidFill>
                  <a:srgbClr val="000066"/>
                </a:solidFill>
                <a:uFillTx/>
                <a:latin typeface="Times New Roman"/>
                <a:hlinkClick r:id="rId1"/>
              </a:rPr>
              <a:t>JEllis@JournalReview.org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),  Tatiana Khrom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Anthony Wong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Mario O Gentile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and Daniel M Siegel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 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 </a:t>
            </a:r>
            <a:br>
              <a:rPr sz="1800"/>
            </a:b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1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Department of Dermatology, SUNY Downstate Medical Center, Brooklyn, New York, 11203, USA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2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Jxnstudio.com, Philadelphia, Pennsylvania, USA</a:t>
            </a:r>
            <a:br>
              <a:rPr sz="1600"/>
            </a:br>
            <a:br>
              <a:rPr sz="1600"/>
            </a:b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BMC Dermatology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2006,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0     doi:10.1186/1471-5945-6-10</a:t>
            </a:r>
            <a:br>
              <a:rPr sz="1600"/>
            </a:b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he electronic version of this article is the complete one and can be found online at: </a:t>
            </a:r>
            <a:r>
              <a:rPr b="0" lang="en-US" sz="16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http://www.biomedcentral.com/1471-5945/6/10</a:t>
            </a:r>
            <a:br>
              <a:rPr sz="1600"/>
            </a:br>
            <a:br>
              <a:rPr sz="1800"/>
            </a:b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Receiv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18 August 200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Accept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6 December 200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Publish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6 December 200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© 2006 Ellis et al; licensee BioMed Central Ltd.</a:t>
            </a:r>
            <a:br>
              <a:rPr sz="900"/>
            </a:b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This is an Open Access article distributed under the terms of the Creative Commons Attribution Licens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(</a:t>
            </a:r>
            <a:r>
              <a:rPr b="0" lang="en-US" sz="9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http://creativecommons.org/licenses/by/2.0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), which permits unrestricted use, distribution, and reproduction in any medium, provided the original work is properly cited.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304920" y="1333440"/>
            <a:ext cx="4286160" cy="285768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4648320" y="2971800"/>
            <a:ext cx="4467240" cy="371484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>
            <a:off x="609480" y="15228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685800" y="20570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457200" y="1590840"/>
            <a:ext cx="4419720" cy="336204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2"/>
          <a:stretch/>
        </p:blipFill>
        <p:spPr>
          <a:xfrm>
            <a:off x="4952880" y="3429000"/>
            <a:ext cx="3943440" cy="29718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7620120" y="4114800"/>
            <a:ext cx="914400" cy="990720"/>
          </a:xfrm>
          <a:prstGeom prst="ellipse">
            <a:avLst/>
          </a:prstGeom>
          <a:noFill/>
          <a:ln w="57240">
            <a:solidFill>
              <a:srgbClr val="ff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533520" y="6338880"/>
            <a:ext cx="8229600" cy="3682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Tumor is extending to the base, and is visible at the tip of the block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1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762120" y="1600200"/>
            <a:ext cx="7238880" cy="507852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315200" cy="513396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762120" y="1600200"/>
            <a:ext cx="7238880" cy="508176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086600" cy="505620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467480" cy="50688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8610480" y="6553080"/>
            <a:ext cx="152640" cy="152640"/>
          </a:xfrm>
          <a:prstGeom prst="ellipse">
            <a:avLst/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852480" y="1623960"/>
            <a:ext cx="7439040" cy="361008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ip Lift – False Negativ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533520" y="6262560"/>
            <a:ext cx="8229600" cy="3682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The tip of the block has been lifted away from the plane of sectioning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09T15:27:39Z</dcterms:created>
  <dc:creator>je</dc:creator>
  <dc:description/>
  <dc:language>en-US</dc:language>
  <cp:lastModifiedBy>JE</cp:lastModifiedBy>
  <dcterms:modified xsi:type="dcterms:W3CDTF">2007-01-03T17:02:17Z</dcterms:modified>
  <cp:revision>3</cp:revision>
  <dc:subject/>
  <dc:title>#3: Tip Lift – False Negative</dc:title>
</cp:coreProperties>
</file>